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0" y="52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1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1/08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Herrema</a:t>
            </a:r>
            <a:r>
              <a:rPr lang="en-GB" dirty="0"/>
              <a:t> and </a:t>
            </a:r>
            <a:r>
              <a:rPr lang="en-GB" dirty="0" err="1"/>
              <a:t>Niess</a:t>
            </a:r>
            <a:r>
              <a:rPr lang="en-GB" dirty="0"/>
              <a:t> (2020) Diabetologia DOI 10.1007/s00125-020-05268-4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44624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Gut-derived microbial metabolites influence host responses in the context of the metabolic syndrome and type 2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D5DFE70-444B-4D65-B163-03F866F357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8607" y="778977"/>
            <a:ext cx="5046785" cy="5085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58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6</cp:revision>
  <dcterms:created xsi:type="dcterms:W3CDTF">2016-06-15T12:53:43Z</dcterms:created>
  <dcterms:modified xsi:type="dcterms:W3CDTF">2020-08-31T15:21:25Z</dcterms:modified>
</cp:coreProperties>
</file>